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4660"/>
  </p:normalViewPr>
  <p:slideViewPr>
    <p:cSldViewPr snapToGrid="0">
      <p:cViewPr varScale="1">
        <p:scale>
          <a:sx n="92" d="100"/>
          <a:sy n="92" d="100"/>
        </p:scale>
        <p:origin x="-300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B3F0F-1E3F-408A-A7A2-67F76BC48905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7C74E-AE8C-4BAC-BC1C-5D21872A1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3608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B3F0F-1E3F-408A-A7A2-67F76BC48905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7C74E-AE8C-4BAC-BC1C-5D21872A1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2867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B3F0F-1E3F-408A-A7A2-67F76BC48905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7C74E-AE8C-4BAC-BC1C-5D21872A1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3625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B3F0F-1E3F-408A-A7A2-67F76BC48905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7C74E-AE8C-4BAC-BC1C-5D21872A1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9099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B3F0F-1E3F-408A-A7A2-67F76BC48905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7C74E-AE8C-4BAC-BC1C-5D21872A1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66986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B3F0F-1E3F-408A-A7A2-67F76BC48905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7C74E-AE8C-4BAC-BC1C-5D21872A1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736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B3F0F-1E3F-408A-A7A2-67F76BC48905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7C74E-AE8C-4BAC-BC1C-5D21872A1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711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B3F0F-1E3F-408A-A7A2-67F76BC48905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7C74E-AE8C-4BAC-BC1C-5D21872A1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134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B3F0F-1E3F-408A-A7A2-67F76BC48905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7C74E-AE8C-4BAC-BC1C-5D21872A1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946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B3F0F-1E3F-408A-A7A2-67F76BC48905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7C74E-AE8C-4BAC-BC1C-5D21872A1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7176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B3F0F-1E3F-408A-A7A2-67F76BC48905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7C74E-AE8C-4BAC-BC1C-5D21872A1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2440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9B3F0F-1E3F-408A-A7A2-67F76BC48905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97C74E-AE8C-4BAC-BC1C-5D21872A1B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482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0" y="-12700"/>
            <a:ext cx="12192000" cy="6081793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07000"/>
              </a:lnSpc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300" dirty="0"/>
              <a:t>cccggatcacactttgagaactgctgctttagtcttcctcccatctcctaaggccagagctcctgagtttgcttcccactggccaaggagaaaagagcaaggtcacttgtcggggggctgcagagggaattaccttctttcatttgcaaatgttactgggggacacaccggctcccagtagggtttccgccaaggctccgcgaaacgccactagagggcgccgctagcgaatcccacagcgcgccccgctgcccccacttttgtcctccgggttcacacgggcgcccggaagagagggtggtgcctgggagaggaaacgatgcgccccggggccgcggcctcattggatgagaggtcccacctcacggcccgaggcggggcttctttgcgcttaaaagccgagccgggccaatgttcaaat</a:t>
            </a:r>
            <a:r>
              <a:rPr lang="en-US" sz="1300" b="1" dirty="0" smtClean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GCAGCTCTTAGTCGCGGGCCGACTGGTGTTTATCCGTCACTCGCCGAGGTTCCTTGGGTCATGGTGCCAGCCTGACTGAGAAGAGGACGCTCCCGGGAGACGAATGAGGAACCACCTCCTCCTACTGTTCAAGTACAGGGGCCTGGTCCGCAAAGGGAAGAAAAGCAAAAGACGAAAATGGCTAAATTCGTGATCCGCCCAGCCACTGCCGCCGACTGCAGTGACATACTGCGGCTGATCAAG</a:t>
            </a:r>
            <a:r>
              <a:rPr lang="en-US" sz="1300" dirty="0" smtClean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agcggagagccagagctcctcccggggcgtggggtggaggtggctccgtttcccagagtggggtgattcacgtcttgaggtctcggccggtgtgagagcccagcctgttcccctttctgcgcccatccccggctcggccgccaccccgcccgcccgccccattccgttcccctgagctggccgggccggagcctcattttgttttctacttttttctctcctatgtgcatccccccag</a:t>
            </a:r>
            <a:r>
              <a:rPr lang="en-US" sz="1300" b="1" dirty="0" smtClean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GCTGGCTAAATATGAATACATGGAAGAACAAGTAATCTTAACTGAAAAAG</a:t>
            </a:r>
            <a:r>
              <a:rPr lang="en-US" sz="1300" dirty="0" smtClean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aattcaacagtggcgggacgggggacaagcgttcggtgcctgtcaccttcgccaaggccattaccgcccctgctcccccttcttgcag</a:t>
            </a:r>
            <a:r>
              <a:rPr lang="en-US" sz="1300" b="1" dirty="0" smtClean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CTGCTAGAAGATGGTTTTGGAGAGCACCCCTTTTACCACTGCCTGGTTGCAGAAGTGCCGAAAGAGCACTGGACTCCGGAAG</a:t>
            </a:r>
            <a:r>
              <a:rPr lang="en-US" sz="1300" dirty="0" smtClean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aacccctcgccctttccagaagccagagagaccaagtgttatgtaagaagtagtgtcggctgtgtagaaccactgactacacaggccgaagttactgagaacttggacagaaaaaatagccagcaagtgttcaaactactgaggaaaaaaaaaaattagatatgctgcacttaagaatactagggcaggttaaaagagctgtttaagtaagtatcagagtgctgtggagactcggaagtgtttaagctgcttaagtaagtataagtgctgtggagacccggaagagttagatataatgtcatttgttgtaattcagtttcataaaatggttcttgtttgaccctaacgtaacagtttttgtaattgtgttaaatcacatttttttctttaatttgtcccaatcttcaggttacagtctctagcttcgccatgtacatggcccttccgtgtacatggatgggcggggaggtaactaaaagatcctttacacaataaagtagatgatcatgataaatgaggtaaggtcctattatcacacacttcaaacacggtagatcagaaacccactatgatactcgcttcctgtctgtttgctaaggaatataaaatggctagaaagtttaatttgaaacctttgcctccatttggaatagtagacaccagttaagagggtgtcagatgccttttttttttttttttttttggctggtccctgttgattggtcagaagacagctcagctaaaaggggaagttgtctgggtggttgctttttttctgacgtctgttcctcaggctggaagaaatgagcagaaaacaagggatgagtactttttagagtatgtgcatgttacgtaatacctgtttctgggcaatgctgcttcttctgactcaacaaatggggagagcaaattgaaaatgcgtaaattggaaggcaagttctgaaattaaacgttgtactttggcctgatgttctgacctttaaggaagcaagagtttgtaaacttccaaatatttactattctgaactgccgtgtaaacctgacgtattcccaagtcaacataccagtataccaataggatgtgaataatgtgtgtgttgagtttaaaaccatagcagttttgctctggcaagtaatgaaagcgttctcgcttcctgagtgtgagctccagcagactgcagagtggccagtccacagttgtagcctgacttcagtgagttctgatgtgtgctttttgcaaatacatgttctcagaacagtgagatcatccagcagtggcctggactgcactcacataaaaatcatgagacagccatggctacttgtttctgtaatacatgcatgtgtgttttttaaaacctatgataggcctctgattctgcagctgcaacttttatggaatgttttccttctccacatctcatgtgatgctcttattacag</a:t>
            </a:r>
            <a:r>
              <a:rPr lang="en-US" sz="1300" b="1" dirty="0" smtClean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CACAGCATTGTTGGTTTTGCCATGTACTATTTTACCTATGACCCGTGGATTGGCAAGTTATTGTATCTTGAGGACTTCTTCGTGATGAGTGATTATAGAG</a:t>
            </a:r>
            <a:r>
              <a:rPr lang="en-US" sz="1300" dirty="0" smtClean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acgattgagttcggagcagagggtctgaagagagttcagagttataaatgcttacaatgactttttaaattgtactctttctttttag</a:t>
            </a:r>
            <a:r>
              <a:rPr lang="en-US" sz="1300" b="1" dirty="0" smtClean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TTTGGCATAGGATCAGAAATTCTGAAGAATCTAAGCCAG</a:t>
            </a:r>
            <a:r>
              <a:rPr lang="en-US" sz="1300" dirty="0" smtClean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atgtcttagtttttggtttccaaatttgtaagtttactggattattttaatgatggaataaaaattgggtcttgagagcaggctgaaatgtcactgagtgtgtgttttactctctcataatag</a:t>
            </a:r>
            <a:r>
              <a:rPr lang="en-US" sz="1300" b="1" dirty="0" smtClean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TGCAATGAGGTGTCGCTGCAGCAGCATGCACTTCTTGGTAGCAGAATGGAATGAACCATCCATCAACTTCTATAAAAGAAGAGGTGCTTCTGATCTGTCCAGTGAAGAGGGTTGGAGACTGTTCAAGATCGACAAGGAGTACTTGCTAAAAATGGCAACAGAGGAGTGAGGAGTGCTGCTGTAGATGACAACCTCCATTCTATTTTAGAATAAATTCCCAACTTCTCTTGCTTTCTATGCTGTTTGTAGTGAAATAATAGAATGAGCACCCATTCCAAAGCTTTATTACCAGTGGCGTTGTTGCATGTTTGAAATGAGGTCTGTTTAAAGTGGCAATCTCAGATGCAGTTTGGAGAGTCAGATCTTTCTCCTTGAATATCTTTCGATAAACAACAAGGTGGTGTGATCTTAATATATTTGAAAAAAACTTCATTCTCGTGAGTCATTTAAATGTGTACAATGTACACACTGGTACTTAGAGTTTCTGTTTGATTCTTTTTTAATAAACTACTCTTTGATTTAATTGTTTGGTGTA</a:t>
            </a:r>
            <a:r>
              <a:rPr lang="en-US" sz="1300" b="1" dirty="0" smtClean="0">
                <a:latin typeface="Courier New" panose="02070309020205020404" pitchFamily="49" charset="0"/>
                <a:ea typeface="Times New Roman" panose="02020603050405020304" pitchFamily="18" charset="0"/>
              </a:rPr>
              <a:t>AGCA</a:t>
            </a:r>
            <a:endParaRPr lang="en-US" sz="1300" b="1" dirty="0"/>
          </a:p>
        </p:txBody>
      </p:sp>
      <p:sp>
        <p:nvSpPr>
          <p:cNvPr id="3" name="TextBox 1"/>
          <p:cNvSpPr txBox="1"/>
          <p:nvPr/>
        </p:nvSpPr>
        <p:spPr>
          <a:xfrm>
            <a:off x="56527" y="6236998"/>
            <a:ext cx="1176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: Sequence of SAT1 gene. Introns are depicted small letters and exons in capital letters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51946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6</TotalTime>
  <Words>21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Miam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jay Singh Thakur</dc:creator>
  <cp:lastModifiedBy>Kiran G</cp:lastModifiedBy>
  <cp:revision>15</cp:revision>
  <dcterms:created xsi:type="dcterms:W3CDTF">2020-03-29T17:33:51Z</dcterms:created>
  <dcterms:modified xsi:type="dcterms:W3CDTF">2020-09-25T02:48:52Z</dcterms:modified>
</cp:coreProperties>
</file>